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7249AEF-3FD3-41E2-9ADF-8E6E01114F96}" v="2" dt="2024-10-23T09:00:59.04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36" d="100"/>
          <a:sy n="36" d="100"/>
        </p:scale>
        <p:origin x="2400" y="44"/>
      </p:cViewPr>
      <p:guideLst>
        <p:guide orient="horz" pos="3840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tthew Letts" userId="188a5684-89dc-43c2-a326-c0685eddec6d" providerId="ADAL" clId="{A1F1F1DB-E074-4BDE-8F14-3E67531DDEAE}"/>
    <pc:docChg chg="modSld">
      <pc:chgData name="Matthew Letts" userId="188a5684-89dc-43c2-a326-c0685eddec6d" providerId="ADAL" clId="{A1F1F1DB-E074-4BDE-8F14-3E67531DDEAE}" dt="2023-11-29T16:33:21.827" v="46" actId="20577"/>
      <pc:docMkLst>
        <pc:docMk/>
      </pc:docMkLst>
      <pc:sldChg chg="modSp mod">
        <pc:chgData name="Matthew Letts" userId="188a5684-89dc-43c2-a326-c0685eddec6d" providerId="ADAL" clId="{A1F1F1DB-E074-4BDE-8F14-3E67531DDEAE}" dt="2023-11-29T16:33:21.827" v="46" actId="20577"/>
        <pc:sldMkLst>
          <pc:docMk/>
          <pc:sldMk cId="2067598130" sldId="256"/>
        </pc:sldMkLst>
        <pc:spChg chg="mod">
          <ac:chgData name="Matthew Letts" userId="188a5684-89dc-43c2-a326-c0685eddec6d" providerId="ADAL" clId="{A1F1F1DB-E074-4BDE-8F14-3E67531DDEAE}" dt="2023-11-29T16:32:40.464" v="0" actId="14100"/>
          <ac:spMkLst>
            <pc:docMk/>
            <pc:sldMk cId="2067598130" sldId="256"/>
            <ac:spMk id="15" creationId="{DF9D8D34-D709-EA02-5E8D-DAC6CD7A9C80}"/>
          </ac:spMkLst>
        </pc:spChg>
        <pc:spChg chg="mod">
          <ac:chgData name="Matthew Letts" userId="188a5684-89dc-43c2-a326-c0685eddec6d" providerId="ADAL" clId="{A1F1F1DB-E074-4BDE-8F14-3E67531DDEAE}" dt="2023-11-29T16:33:21.827" v="46" actId="20577"/>
          <ac:spMkLst>
            <pc:docMk/>
            <pc:sldMk cId="2067598130" sldId="256"/>
            <ac:spMk id="24" creationId="{633334E2-8DA8-B330-50CF-CBB13F00219C}"/>
          </ac:spMkLst>
        </pc:spChg>
        <pc:cxnChg chg="mod">
          <ac:chgData name="Matthew Letts" userId="188a5684-89dc-43c2-a326-c0685eddec6d" providerId="ADAL" clId="{A1F1F1DB-E074-4BDE-8F14-3E67531DDEAE}" dt="2023-11-29T16:32:40.464" v="0" actId="14100"/>
          <ac:cxnSpMkLst>
            <pc:docMk/>
            <pc:sldMk cId="2067598130" sldId="256"/>
            <ac:cxnSpMk id="4" creationId="{43792396-564E-073C-F409-FDF215681EB3}"/>
          </ac:cxnSpMkLst>
        </pc:cxnChg>
      </pc:sldChg>
    </pc:docChg>
  </pc:docChgLst>
  <pc:docChgLst>
    <pc:chgData name="Matthew Letts" userId="188a5684-89dc-43c2-a326-c0685eddec6d" providerId="ADAL" clId="{89AC1048-E68A-4AFB-BD7A-6D8B2DE54FD0}"/>
    <pc:docChg chg="undo custSel modSld">
      <pc:chgData name="Matthew Letts" userId="188a5684-89dc-43c2-a326-c0685eddec6d" providerId="ADAL" clId="{89AC1048-E68A-4AFB-BD7A-6D8B2DE54FD0}" dt="2024-02-22T16:20:17.252" v="65" actId="20577"/>
      <pc:docMkLst>
        <pc:docMk/>
      </pc:docMkLst>
      <pc:sldChg chg="modSp mod">
        <pc:chgData name="Matthew Letts" userId="188a5684-89dc-43c2-a326-c0685eddec6d" providerId="ADAL" clId="{89AC1048-E68A-4AFB-BD7A-6D8B2DE54FD0}" dt="2024-02-22T16:20:17.252" v="65" actId="20577"/>
        <pc:sldMkLst>
          <pc:docMk/>
          <pc:sldMk cId="2067598130" sldId="256"/>
        </pc:sldMkLst>
        <pc:spChg chg="mod">
          <ac:chgData name="Matthew Letts" userId="188a5684-89dc-43c2-a326-c0685eddec6d" providerId="ADAL" clId="{89AC1048-E68A-4AFB-BD7A-6D8B2DE54FD0}" dt="2024-02-22T16:20:17.252" v="65" actId="20577"/>
          <ac:spMkLst>
            <pc:docMk/>
            <pc:sldMk cId="2067598130" sldId="256"/>
            <ac:spMk id="12" creationId="{E9E904A7-4DC4-077C-A868-CA9434CD7CFB}"/>
          </ac:spMkLst>
        </pc:spChg>
        <pc:spChg chg="mod">
          <ac:chgData name="Matthew Letts" userId="188a5684-89dc-43c2-a326-c0685eddec6d" providerId="ADAL" clId="{89AC1048-E68A-4AFB-BD7A-6D8B2DE54FD0}" dt="2024-02-22T16:20:12.963" v="59" actId="20577"/>
          <ac:spMkLst>
            <pc:docMk/>
            <pc:sldMk cId="2067598130" sldId="256"/>
            <ac:spMk id="15" creationId="{DF9D8D34-D709-EA02-5E8D-DAC6CD7A9C80}"/>
          </ac:spMkLst>
        </pc:spChg>
        <pc:spChg chg="mod">
          <ac:chgData name="Matthew Letts" userId="188a5684-89dc-43c2-a326-c0685eddec6d" providerId="ADAL" clId="{89AC1048-E68A-4AFB-BD7A-6D8B2DE54FD0}" dt="2024-02-21T12:35:44.624" v="47" actId="20577"/>
          <ac:spMkLst>
            <pc:docMk/>
            <pc:sldMk cId="2067598130" sldId="256"/>
            <ac:spMk id="18" creationId="{BE3B7E94-751E-26B4-87D8-2BA7781B2F6B}"/>
          </ac:spMkLst>
        </pc:spChg>
      </pc:sldChg>
    </pc:docChg>
  </pc:docChgLst>
  <pc:docChgLst>
    <pc:chgData name="Matthew Letts" userId="188a5684-89dc-43c2-a326-c0685eddec6d" providerId="ADAL" clId="{B3B55FF9-FB0B-41DC-ADE4-47E8848C6279}"/>
    <pc:docChg chg="modSld">
      <pc:chgData name="Matthew Letts" userId="188a5684-89dc-43c2-a326-c0685eddec6d" providerId="ADAL" clId="{B3B55FF9-FB0B-41DC-ADE4-47E8848C6279}" dt="2024-01-16T11:03:42.979" v="32" actId="20577"/>
      <pc:docMkLst>
        <pc:docMk/>
      </pc:docMkLst>
      <pc:sldChg chg="modSp mod">
        <pc:chgData name="Matthew Letts" userId="188a5684-89dc-43c2-a326-c0685eddec6d" providerId="ADAL" clId="{B3B55FF9-FB0B-41DC-ADE4-47E8848C6279}" dt="2024-01-16T11:03:42.979" v="32" actId="20577"/>
        <pc:sldMkLst>
          <pc:docMk/>
          <pc:sldMk cId="2067598130" sldId="256"/>
        </pc:sldMkLst>
        <pc:spChg chg="mod">
          <ac:chgData name="Matthew Letts" userId="188a5684-89dc-43c2-a326-c0685eddec6d" providerId="ADAL" clId="{B3B55FF9-FB0B-41DC-ADE4-47E8848C6279}" dt="2024-01-16T11:03:42.979" v="32" actId="20577"/>
          <ac:spMkLst>
            <pc:docMk/>
            <pc:sldMk cId="2067598130" sldId="256"/>
            <ac:spMk id="15" creationId="{DF9D8D34-D709-EA02-5E8D-DAC6CD7A9C80}"/>
          </ac:spMkLst>
        </pc:spChg>
      </pc:sldChg>
    </pc:docChg>
  </pc:docChgLst>
  <pc:docChgLst>
    <pc:chgData name="Matthew Letts" userId="188a5684-89dc-43c2-a326-c0685eddec6d" providerId="ADAL" clId="{F7249AEF-3FD3-41E2-9ADF-8E6E01114F96}"/>
    <pc:docChg chg="undo custSel modSld">
      <pc:chgData name="Matthew Letts" userId="188a5684-89dc-43c2-a326-c0685eddec6d" providerId="ADAL" clId="{F7249AEF-3FD3-41E2-9ADF-8E6E01114F96}" dt="2024-10-23T09:01:41.168" v="58" actId="1076"/>
      <pc:docMkLst>
        <pc:docMk/>
      </pc:docMkLst>
      <pc:sldChg chg="addSp modSp mod">
        <pc:chgData name="Matthew Letts" userId="188a5684-89dc-43c2-a326-c0685eddec6d" providerId="ADAL" clId="{F7249AEF-3FD3-41E2-9ADF-8E6E01114F96}" dt="2024-10-23T09:01:41.168" v="58" actId="1076"/>
        <pc:sldMkLst>
          <pc:docMk/>
          <pc:sldMk cId="2067598130" sldId="256"/>
        </pc:sldMkLst>
        <pc:spChg chg="add mod">
          <ac:chgData name="Matthew Letts" userId="188a5684-89dc-43c2-a326-c0685eddec6d" providerId="ADAL" clId="{F7249AEF-3FD3-41E2-9ADF-8E6E01114F96}" dt="2024-10-23T09:01:34.935" v="57" actId="14100"/>
          <ac:spMkLst>
            <pc:docMk/>
            <pc:sldMk cId="2067598130" sldId="256"/>
            <ac:spMk id="6" creationId="{6BD63F04-AE5D-D6A0-3DE2-7909FE089074}"/>
          </ac:spMkLst>
        </pc:spChg>
        <pc:grpChg chg="mod">
          <ac:chgData name="Matthew Letts" userId="188a5684-89dc-43c2-a326-c0685eddec6d" providerId="ADAL" clId="{F7249AEF-3FD3-41E2-9ADF-8E6E01114F96}" dt="2024-10-23T09:00:59.046" v="50" actId="164"/>
          <ac:grpSpMkLst>
            <pc:docMk/>
            <pc:sldMk cId="2067598130" sldId="256"/>
            <ac:grpSpMk id="2" creationId="{06AF380E-173E-5FB1-D058-BADD6B90C972}"/>
          </ac:grpSpMkLst>
        </pc:grpChg>
        <pc:grpChg chg="add mod">
          <ac:chgData name="Matthew Letts" userId="188a5684-89dc-43c2-a326-c0685eddec6d" providerId="ADAL" clId="{F7249AEF-3FD3-41E2-9ADF-8E6E01114F96}" dt="2024-10-23T09:01:41.168" v="58" actId="1076"/>
          <ac:grpSpMkLst>
            <pc:docMk/>
            <pc:sldMk cId="2067598130" sldId="256"/>
            <ac:grpSpMk id="8" creationId="{34E249C1-DE14-FF32-466A-620AD154A08E}"/>
          </ac:grpSpMkLst>
        </pc:grpChg>
        <pc:grpChg chg="mod">
          <ac:chgData name="Matthew Letts" userId="188a5684-89dc-43c2-a326-c0685eddec6d" providerId="ADAL" clId="{F7249AEF-3FD3-41E2-9ADF-8E6E01114F96}" dt="2024-10-23T09:00:59.046" v="50" actId="164"/>
          <ac:grpSpMkLst>
            <pc:docMk/>
            <pc:sldMk cId="2067598130" sldId="256"/>
            <ac:grpSpMk id="47" creationId="{B614A5A4-8F1A-B7F6-80CE-D1C3B712563E}"/>
          </ac:grpSpMkLst>
        </pc:grpChg>
      </pc:sldChg>
    </pc:docChg>
  </pc:docChgLst>
  <pc:docChgLst>
    <pc:chgData name="Matthew Letts" userId="188a5684-89dc-43c2-a326-c0685eddec6d" providerId="ADAL" clId="{EEAE5DF3-4B67-4AE9-8947-98C5F06CEE32}"/>
    <pc:docChg chg="modSld">
      <pc:chgData name="Matthew Letts" userId="188a5684-89dc-43c2-a326-c0685eddec6d" providerId="ADAL" clId="{EEAE5DF3-4B67-4AE9-8947-98C5F06CEE32}" dt="2024-03-31T03:11:18.971" v="4" actId="20577"/>
      <pc:docMkLst>
        <pc:docMk/>
      </pc:docMkLst>
      <pc:sldChg chg="modSp mod">
        <pc:chgData name="Matthew Letts" userId="188a5684-89dc-43c2-a326-c0685eddec6d" providerId="ADAL" clId="{EEAE5DF3-4B67-4AE9-8947-98C5F06CEE32}" dt="2024-03-31T03:11:18.971" v="4" actId="20577"/>
        <pc:sldMkLst>
          <pc:docMk/>
          <pc:sldMk cId="2067598130" sldId="256"/>
        </pc:sldMkLst>
        <pc:spChg chg="mod">
          <ac:chgData name="Matthew Letts" userId="188a5684-89dc-43c2-a326-c0685eddec6d" providerId="ADAL" clId="{EEAE5DF3-4B67-4AE9-8947-98C5F06CEE32}" dt="2024-03-31T03:11:18.971" v="4" actId="20577"/>
          <ac:spMkLst>
            <pc:docMk/>
            <pc:sldMk cId="2067598130" sldId="256"/>
            <ac:spMk id="23" creationId="{71F5DFB4-96EC-9173-BEF4-9405F0744D8D}"/>
          </ac:spMkLst>
        </pc:spChg>
      </pc:sldChg>
    </pc:docChg>
  </pc:docChgLst>
  <pc:docChgLst>
    <pc:chgData name="Matthew Letts" userId="188a5684-89dc-43c2-a326-c0685eddec6d" providerId="ADAL" clId="{17800C46-41F5-44CA-A509-7D6CCA018A06}"/>
    <pc:docChg chg="modSld">
      <pc:chgData name="Matthew Letts" userId="188a5684-89dc-43c2-a326-c0685eddec6d" providerId="ADAL" clId="{17800C46-41F5-44CA-A509-7D6CCA018A06}" dt="2024-02-23T10:45:17.907" v="19" actId="20577"/>
      <pc:docMkLst>
        <pc:docMk/>
      </pc:docMkLst>
      <pc:sldChg chg="modSp mod">
        <pc:chgData name="Matthew Letts" userId="188a5684-89dc-43c2-a326-c0685eddec6d" providerId="ADAL" clId="{17800C46-41F5-44CA-A509-7D6CCA018A06}" dt="2024-02-23T10:45:17.907" v="19" actId="20577"/>
        <pc:sldMkLst>
          <pc:docMk/>
          <pc:sldMk cId="2067598130" sldId="256"/>
        </pc:sldMkLst>
        <pc:spChg chg="mod">
          <ac:chgData name="Matthew Letts" userId="188a5684-89dc-43c2-a326-c0685eddec6d" providerId="ADAL" clId="{17800C46-41F5-44CA-A509-7D6CCA018A06}" dt="2024-02-23T10:44:16.911" v="11" actId="20577"/>
          <ac:spMkLst>
            <pc:docMk/>
            <pc:sldMk cId="2067598130" sldId="256"/>
            <ac:spMk id="9" creationId="{979DC2F9-767C-55F5-3E2D-6EC5851B0287}"/>
          </ac:spMkLst>
        </pc:spChg>
        <pc:spChg chg="mod">
          <ac:chgData name="Matthew Letts" userId="188a5684-89dc-43c2-a326-c0685eddec6d" providerId="ADAL" clId="{17800C46-41F5-44CA-A509-7D6CCA018A06}" dt="2024-02-23T10:45:17.907" v="19" actId="20577"/>
          <ac:spMkLst>
            <pc:docMk/>
            <pc:sldMk cId="2067598130" sldId="256"/>
            <ac:spMk id="15" creationId="{DF9D8D34-D709-EA02-5E8D-DAC6CD7A9C80}"/>
          </ac:spMkLst>
        </pc:spChg>
        <pc:spChg chg="mod">
          <ac:chgData name="Matthew Letts" userId="188a5684-89dc-43c2-a326-c0685eddec6d" providerId="ADAL" clId="{17800C46-41F5-44CA-A509-7D6CCA018A06}" dt="2024-02-23T10:44:51.556" v="15" actId="20577"/>
          <ac:spMkLst>
            <pc:docMk/>
            <pc:sldMk cId="2067598130" sldId="256"/>
            <ac:spMk id="24" creationId="{633334E2-8DA8-B330-50CF-CBB13F00219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454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9959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174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695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5768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046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9938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1793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8190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36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604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087BB5-818A-4A67-8C8B-912947EB46B8}" type="datetimeFigureOut">
              <a:rPr lang="en-GB" smtClean="0"/>
              <a:t>2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ED7B8-8A84-49FA-8699-9B8AF486AD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17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34E249C1-DE14-FF32-466A-620AD154A08E}"/>
              </a:ext>
            </a:extLst>
          </p:cNvPr>
          <p:cNvGrpSpPr/>
          <p:nvPr/>
        </p:nvGrpSpPr>
        <p:grpSpPr>
          <a:xfrm>
            <a:off x="125719" y="879697"/>
            <a:ext cx="6609396" cy="10432605"/>
            <a:chOff x="121014" y="88438"/>
            <a:chExt cx="6609396" cy="10432605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B614A5A4-8F1A-B7F6-80CE-D1C3B712563E}"/>
                </a:ext>
              </a:extLst>
            </p:cNvPr>
            <p:cNvGrpSpPr/>
            <p:nvPr/>
          </p:nvGrpSpPr>
          <p:grpSpPr>
            <a:xfrm>
              <a:off x="121015" y="88438"/>
              <a:ext cx="6609395" cy="7462322"/>
              <a:chOff x="178981" y="292319"/>
              <a:chExt cx="6609395" cy="7462322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3137F272-9D24-7FA0-C9DE-B8770C41EA02}"/>
                  </a:ext>
                </a:extLst>
              </p:cNvPr>
              <p:cNvGrpSpPr/>
              <p:nvPr/>
            </p:nvGrpSpPr>
            <p:grpSpPr>
              <a:xfrm>
                <a:off x="178981" y="292319"/>
                <a:ext cx="6609395" cy="7462322"/>
                <a:chOff x="479205" y="565028"/>
                <a:chExt cx="6609395" cy="7462322"/>
              </a:xfrm>
            </p:grpSpPr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F8FA8AC3-3825-9649-860D-17E796101470}"/>
                    </a:ext>
                  </a:extLst>
                </p:cNvPr>
                <p:cNvGrpSpPr/>
                <p:nvPr/>
              </p:nvGrpSpPr>
              <p:grpSpPr>
                <a:xfrm>
                  <a:off x="479205" y="565028"/>
                  <a:ext cx="6609395" cy="6258902"/>
                  <a:chOff x="407205" y="322077"/>
                  <a:chExt cx="6609395" cy="6258902"/>
                </a:xfrm>
              </p:grpSpPr>
              <p:grpSp>
                <p:nvGrpSpPr>
                  <p:cNvPr id="13" name="Group 12">
                    <a:extLst>
                      <a:ext uri="{FF2B5EF4-FFF2-40B4-BE49-F238E27FC236}">
                        <a16:creationId xmlns:a16="http://schemas.microsoft.com/office/drawing/2014/main" id="{51339DB5-1C12-25DF-16D7-102B110855CD}"/>
                      </a:ext>
                    </a:extLst>
                  </p:cNvPr>
                  <p:cNvGrpSpPr/>
                  <p:nvPr/>
                </p:nvGrpSpPr>
                <p:grpSpPr>
                  <a:xfrm>
                    <a:off x="407205" y="322077"/>
                    <a:ext cx="6609395" cy="6258902"/>
                    <a:chOff x="407205" y="322077"/>
                    <a:chExt cx="6609395" cy="6258902"/>
                  </a:xfrm>
                </p:grpSpPr>
                <p:sp>
                  <p:nvSpPr>
                    <p:cNvPr id="18" name="TextBox 17">
                      <a:extLst>
                        <a:ext uri="{FF2B5EF4-FFF2-40B4-BE49-F238E27FC236}">
                          <a16:creationId xmlns:a16="http://schemas.microsoft.com/office/drawing/2014/main" id="{BE3B7E94-751E-26B4-87D8-2BA7781B2F6B}"/>
                        </a:ext>
                      </a:extLst>
                    </p:cNvPr>
                    <p:cNvSpPr txBox="1">
                      <a:spLocks/>
                    </p:cNvSpPr>
                    <p:nvPr/>
                  </p:nvSpPr>
                  <p:spPr>
                    <a:xfrm>
                      <a:off x="407205" y="322077"/>
                      <a:ext cx="2452949" cy="1077218"/>
                    </a:xfrm>
                    <a:prstGeom prst="rect">
                      <a:avLst/>
                    </a:prstGeom>
                    <a:noFill/>
                  </p:spPr>
                  <p:style>
                    <a:lnRef idx="2">
                      <a:schemeClr val="accent1">
                        <a:shade val="15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2200" b="1" dirty="0">
                          <a:solidFill>
                            <a:schemeClr val="tx1"/>
                          </a:solidFill>
                        </a:rPr>
                        <a:t>Total EQUAL cohort </a:t>
                      </a:r>
                      <a:br>
                        <a:rPr lang="en-GB" sz="2200" dirty="0">
                          <a:solidFill>
                            <a:schemeClr val="tx1"/>
                          </a:solidFill>
                        </a:rPr>
                      </a:br>
                      <a:r>
                        <a:rPr lang="en-GB" sz="1400" dirty="0">
                          <a:solidFill>
                            <a:schemeClr val="tx1"/>
                          </a:solidFill>
                        </a:rPr>
                        <a:t>1,736 participants;</a:t>
                      </a:r>
                    </a:p>
                    <a:p>
                      <a:pPr algn="ctr"/>
                      <a:r>
                        <a:rPr lang="en-GB" sz="1400" dirty="0">
                          <a:solidFill>
                            <a:schemeClr val="tx1"/>
                          </a:solidFill>
                        </a:rPr>
                        <a:t>11,423 study visits;</a:t>
                      </a:r>
                    </a:p>
                    <a:p>
                      <a:pPr algn="ctr"/>
                      <a:r>
                        <a:rPr lang="en-GB" sz="1400" dirty="0">
                          <a:solidFill>
                            <a:schemeClr val="tx1"/>
                          </a:solidFill>
                        </a:rPr>
                        <a:t>79,105 prescribed medications</a:t>
                      </a:r>
                    </a:p>
                  </p:txBody>
                </p:sp>
                <p:grpSp>
                  <p:nvGrpSpPr>
                    <p:cNvPr id="19" name="Group 18">
                      <a:extLst>
                        <a:ext uri="{FF2B5EF4-FFF2-40B4-BE49-F238E27FC236}">
                          <a16:creationId xmlns:a16="http://schemas.microsoft.com/office/drawing/2014/main" id="{AF385D45-8906-E6F0-863E-4B68F542EB6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07205" y="1537948"/>
                      <a:ext cx="6609395" cy="5043031"/>
                      <a:chOff x="407205" y="1537948"/>
                      <a:chExt cx="6609395" cy="5043031"/>
                    </a:xfrm>
                  </p:grpSpPr>
                  <p:sp>
                    <p:nvSpPr>
                      <p:cNvPr id="20" name="TextBox 19">
                        <a:extLst>
                          <a:ext uri="{FF2B5EF4-FFF2-40B4-BE49-F238E27FC236}">
                            <a16:creationId xmlns:a16="http://schemas.microsoft.com/office/drawing/2014/main" id="{7917AB8C-2985-59E7-0A01-C8800ED914B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07205" y="4792784"/>
                        <a:ext cx="2434685" cy="1077218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2200" b="1" dirty="0">
                            <a:solidFill>
                              <a:schemeClr val="tx1"/>
                            </a:solidFill>
                          </a:rPr>
                          <a:t>Analysable cohort</a:t>
                        </a:r>
                        <a:br>
                          <a:rPr lang="en-GB" sz="2200" dirty="0">
                            <a:solidFill>
                              <a:schemeClr val="tx1"/>
                            </a:solidFill>
                          </a:rPr>
                        </a:br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1,371 participants;</a:t>
                        </a:r>
                      </a:p>
                      <a:p>
                        <a:pPr algn="ctr"/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7,627 study visits;</a:t>
                        </a:r>
                      </a:p>
                      <a:p>
                        <a:pPr algn="ctr"/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66,075 prescribed medications</a:t>
                        </a:r>
                      </a:p>
                    </p:txBody>
                  </p:sp>
                  <p:sp>
                    <p:nvSpPr>
                      <p:cNvPr id="21" name="TextBox 20">
                        <a:extLst>
                          <a:ext uri="{FF2B5EF4-FFF2-40B4-BE49-F238E27FC236}">
                            <a16:creationId xmlns:a16="http://schemas.microsoft.com/office/drawing/2014/main" id="{AABE1706-FF98-8048-7A47-1E8BC725491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8564" y="1537948"/>
                        <a:ext cx="5384728" cy="738664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3">
                          <a:shade val="15000"/>
                        </a:schemeClr>
                      </a:lnRef>
                      <a:fillRef idx="1">
                        <a:schemeClr val="accent3"/>
                      </a:fillRef>
                      <a:effectRef idx="0">
                        <a:schemeClr val="accent3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400" b="1" dirty="0">
                            <a:solidFill>
                              <a:schemeClr val="tx1"/>
                            </a:solidFill>
                          </a:rPr>
                          <a:t>Whole participant exclusion: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Swedish data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	305 participants; 2,373 study visits; 8,232 prescribed medications</a:t>
                        </a:r>
                      </a:p>
                    </p:txBody>
                  </p:sp>
                  <p:sp>
                    <p:nvSpPr>
                      <p:cNvPr id="23" name="TextBox 22">
                        <a:extLst>
                          <a:ext uri="{FF2B5EF4-FFF2-40B4-BE49-F238E27FC236}">
                            <a16:creationId xmlns:a16="http://schemas.microsoft.com/office/drawing/2014/main" id="{71F5DFB4-96EC-9173-BEF4-9405F0744D8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8564" y="2407772"/>
                        <a:ext cx="6198036" cy="2246769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2">
                          <a:shade val="15000"/>
                        </a:schemeClr>
                      </a:lnRef>
                      <a:fillRef idx="1">
                        <a:schemeClr val="accent2"/>
                      </a:fillRef>
                      <a:effectRef idx="0">
                        <a:schemeClr val="accent2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400" b="1" dirty="0">
                            <a:solidFill>
                              <a:schemeClr val="tx1"/>
                            </a:solidFill>
                          </a:rPr>
                          <a:t>Single study visit exclusion: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Duplicated data 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	188 study visits and 1,660 prescribed medications, across 132 participants; 	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	0 participants excluded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Missing data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	1,034 study visits and 1,330 prescribed medications, across 413 participants; 	54 participants excluded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Medication data recorded after participant’s death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	201 study visits and 1,808 prescribed medications, across 191 participants;</a:t>
                        </a:r>
                      </a:p>
                      <a:p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	6 participants excluded</a:t>
                        </a:r>
                      </a:p>
                    </p:txBody>
                  </p:sp>
                  <p:sp>
                    <p:nvSpPr>
                      <p:cNvPr id="24" name="TextBox 23">
                        <a:extLst>
                          <a:ext uri="{FF2B5EF4-FFF2-40B4-BE49-F238E27FC236}">
                            <a16:creationId xmlns:a16="http://schemas.microsoft.com/office/drawing/2014/main" id="{633334E2-8DA8-B330-50CF-CBB13F00219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8564" y="5996204"/>
                        <a:ext cx="5549449" cy="584775"/>
                      </a:xfrm>
                      <a:prstGeom prst="rect">
                        <a:avLst/>
                      </a:prstGeom>
                      <a:noFill/>
                    </p:spPr>
                    <p:style>
                      <a:lnRef idx="2">
                        <a:schemeClr val="accent3">
                          <a:shade val="15000"/>
                        </a:schemeClr>
                      </a:lnRef>
                      <a:fillRef idx="1">
                        <a:schemeClr val="accent3"/>
                      </a:fillRef>
                      <a:effectRef idx="0">
                        <a:schemeClr val="accent3"/>
                      </a:effectRef>
                      <a:fontRef idx="minor">
                        <a:schemeClr val="lt1"/>
                      </a:fontRef>
                    </p:style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400" b="1" dirty="0">
                            <a:solidFill>
                              <a:schemeClr val="tx1"/>
                            </a:solidFill>
                          </a:rPr>
                          <a:t>Exclusion of those who did not die during study follow up:</a:t>
                        </a:r>
                        <a:endParaRPr lang="en-GB" b="1" dirty="0">
                          <a:solidFill>
                            <a:schemeClr val="tx1"/>
                          </a:solidFill>
                        </a:endParaRPr>
                      </a:p>
                      <a:p>
                        <a:r>
                          <a:rPr lang="en-GB" dirty="0">
                            <a:solidFill>
                              <a:schemeClr val="tx1"/>
                            </a:solidFill>
                          </a:rPr>
                          <a:t>	</a:t>
                        </a:r>
                        <a:r>
                          <a:rPr lang="en-GB" sz="1400" dirty="0">
                            <a:solidFill>
                              <a:schemeClr val="tx1"/>
                            </a:solidFill>
                          </a:rPr>
                          <a:t>808 participants; 4,834 study visits; 40,998 prescribed medications</a:t>
                        </a:r>
                        <a:r>
                          <a:rPr lang="en-GB" sz="1400" dirty="0"/>
                          <a:t>)</a:t>
                        </a:r>
                      </a:p>
                    </p:txBody>
                  </p:sp>
                </p:grpSp>
              </p:grpSp>
              <p:cxnSp>
                <p:nvCxnSpPr>
                  <p:cNvPr id="14" name="Straight Arrow Connector 13">
                    <a:extLst>
                      <a:ext uri="{FF2B5EF4-FFF2-40B4-BE49-F238E27FC236}">
                        <a16:creationId xmlns:a16="http://schemas.microsoft.com/office/drawing/2014/main" id="{81B34160-F477-7BFB-B103-ED68E7FE160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12884" y="1399295"/>
                    <a:ext cx="0" cy="3393489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979DC2F9-767C-55F5-3E2D-6EC5851B0287}"/>
                    </a:ext>
                  </a:extLst>
                </p:cNvPr>
                <p:cNvSpPr txBox="1"/>
                <p:nvPr/>
              </p:nvSpPr>
              <p:spPr>
                <a:xfrm>
                  <a:off x="479212" y="6950132"/>
                  <a:ext cx="2452942" cy="1077218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2200" b="1" dirty="0">
                      <a:solidFill>
                        <a:schemeClr val="tx1"/>
                      </a:solidFill>
                    </a:rPr>
                    <a:t>Decedent cohort</a:t>
                  </a:r>
                </a:p>
                <a:p>
                  <a:pPr algn="ctr"/>
                  <a:r>
                    <a:rPr lang="en-GB" sz="1400" dirty="0">
                      <a:solidFill>
                        <a:schemeClr val="tx1"/>
                      </a:solidFill>
                    </a:rPr>
                    <a:t>563 participants;</a:t>
                  </a:r>
                </a:p>
                <a:p>
                  <a:pPr algn="ctr"/>
                  <a:r>
                    <a:rPr lang="en-GB" sz="1400" dirty="0">
                      <a:solidFill>
                        <a:schemeClr val="tx1"/>
                      </a:solidFill>
                    </a:rPr>
                    <a:t>2,793 study visits;</a:t>
                  </a:r>
                </a:p>
                <a:p>
                  <a:pPr algn="ctr"/>
                  <a:r>
                    <a:rPr lang="en-GB" sz="1400" dirty="0">
                      <a:solidFill>
                        <a:schemeClr val="tx1"/>
                      </a:solidFill>
                    </a:rPr>
                    <a:t>25,077 prescribed medications</a:t>
                  </a:r>
                </a:p>
              </p:txBody>
            </p:sp>
          </p:grpSp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id="{5321EC77-EE83-4879-5E97-C932A4B207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4660" y="1874838"/>
                <a:ext cx="20568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>
                <a:extLst>
                  <a:ext uri="{FF2B5EF4-FFF2-40B4-BE49-F238E27FC236}">
                    <a16:creationId xmlns:a16="http://schemas.microsoft.com/office/drawing/2014/main" id="{6D341862-920B-B2C3-8AE5-4EA0F4ED3864}"/>
                  </a:ext>
                </a:extLst>
              </p:cNvPr>
              <p:cNvCxnSpPr>
                <a:cxnSpLocks/>
                <a:endCxn id="23" idx="1"/>
              </p:cNvCxnSpPr>
              <p:nvPr/>
            </p:nvCxnSpPr>
            <p:spPr>
              <a:xfrm flipV="1">
                <a:off x="384660" y="3501399"/>
                <a:ext cx="205680" cy="2124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>
                <a:extLst>
                  <a:ext uri="{FF2B5EF4-FFF2-40B4-BE49-F238E27FC236}">
                    <a16:creationId xmlns:a16="http://schemas.microsoft.com/office/drawing/2014/main" id="{0F11626C-B939-4F11-3CF6-D7765DDCF2F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012" y="5840244"/>
                <a:ext cx="0" cy="84949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>
                <a:extLst>
                  <a:ext uri="{FF2B5EF4-FFF2-40B4-BE49-F238E27FC236}">
                    <a16:creationId xmlns:a16="http://schemas.microsoft.com/office/drawing/2014/main" id="{A6106A08-970B-C1E4-5F96-4A84505305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4617" y="6299881"/>
                <a:ext cx="220076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6AF380E-173E-5FB1-D058-BADD6B90C972}"/>
                </a:ext>
              </a:extLst>
            </p:cNvPr>
            <p:cNvGrpSpPr/>
            <p:nvPr/>
          </p:nvGrpSpPr>
          <p:grpSpPr>
            <a:xfrm>
              <a:off x="121014" y="7550760"/>
              <a:ext cx="3307979" cy="2970283"/>
              <a:chOff x="-238866" y="248648"/>
              <a:chExt cx="3307979" cy="2970283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A1AC933D-A9A9-2C59-66D6-47CC80A22029}"/>
                  </a:ext>
                </a:extLst>
              </p:cNvPr>
              <p:cNvGrpSpPr/>
              <p:nvPr/>
            </p:nvGrpSpPr>
            <p:grpSpPr>
              <a:xfrm>
                <a:off x="-238866" y="248648"/>
                <a:ext cx="3307979" cy="2970283"/>
                <a:chOff x="-238866" y="248648"/>
                <a:chExt cx="3307979" cy="2970283"/>
              </a:xfrm>
            </p:grpSpPr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5855214F-A7FA-E2D8-3F8B-98FD132E9A09}"/>
                    </a:ext>
                  </a:extLst>
                </p:cNvPr>
                <p:cNvGrpSpPr/>
                <p:nvPr/>
              </p:nvGrpSpPr>
              <p:grpSpPr>
                <a:xfrm>
                  <a:off x="-238866" y="400199"/>
                  <a:ext cx="3307979" cy="2818732"/>
                  <a:chOff x="-43854" y="474201"/>
                  <a:chExt cx="3307979" cy="2818732"/>
                </a:xfrm>
              </p:grpSpPr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E9E904A7-4DC4-077C-A868-CA9434CD7CFB}"/>
                      </a:ext>
                    </a:extLst>
                  </p:cNvPr>
                  <p:cNvSpPr txBox="1"/>
                  <p:nvPr/>
                </p:nvSpPr>
                <p:spPr>
                  <a:xfrm>
                    <a:off x="-43854" y="2215715"/>
                    <a:ext cx="3307979" cy="1077218"/>
                  </a:xfrm>
                  <a:prstGeom prst="rect">
                    <a:avLst/>
                  </a:prstGeom>
                  <a:noFill/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2200" b="1" dirty="0">
                        <a:solidFill>
                          <a:schemeClr val="tx1"/>
                        </a:solidFill>
                      </a:rPr>
                      <a:t>Analysed decedent cohort</a:t>
                    </a:r>
                  </a:p>
                  <a:p>
                    <a:pPr algn="ctr"/>
                    <a:r>
                      <a:rPr lang="en-GB" sz="1400" dirty="0">
                        <a:solidFill>
                          <a:schemeClr val="tx1"/>
                        </a:solidFill>
                      </a:rPr>
                      <a:t>563 participants;</a:t>
                    </a:r>
                  </a:p>
                  <a:p>
                    <a:pPr algn="ctr"/>
                    <a:r>
                      <a:rPr lang="en-GB" sz="1400" dirty="0">
                        <a:solidFill>
                          <a:schemeClr val="tx1"/>
                        </a:solidFill>
                      </a:rPr>
                      <a:t>2,793 study visits;</a:t>
                    </a:r>
                    <a:br>
                      <a:rPr lang="en-GB" sz="2200" dirty="0">
                        <a:solidFill>
                          <a:schemeClr val="tx1"/>
                        </a:solidFill>
                      </a:rPr>
                    </a:br>
                    <a:r>
                      <a:rPr lang="en-GB" sz="1400" dirty="0">
                        <a:solidFill>
                          <a:schemeClr val="tx1"/>
                        </a:solidFill>
                      </a:rPr>
                      <a:t>22,173 prescribed medications</a:t>
                    </a:r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DF9D8D34-D709-EA02-5E8D-DAC6CD7A9C80}"/>
                      </a:ext>
                    </a:extLst>
                  </p:cNvPr>
                  <p:cNvSpPr txBox="1"/>
                  <p:nvPr/>
                </p:nvSpPr>
                <p:spPr>
                  <a:xfrm>
                    <a:off x="367507" y="474201"/>
                    <a:ext cx="2784984" cy="1600438"/>
                  </a:xfrm>
                  <a:prstGeom prst="rect">
                    <a:avLst/>
                  </a:prstGeom>
                  <a:noFill/>
                </p:spPr>
                <p:style>
                  <a:lnRef idx="2">
                    <a:schemeClr val="accent2">
                      <a:shade val="15000"/>
                    </a:schemeClr>
                  </a:lnRef>
                  <a:fillRef idx="1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lt1"/>
                  </a:fontRef>
                </p:style>
                <p:txBody>
                  <a:bodyPr wrap="square" rtlCol="0">
                    <a:spAutoFit/>
                  </a:bodyPr>
                  <a:lstStyle/>
                  <a:p>
                    <a:r>
                      <a:rPr lang="en-GB" sz="1400" b="1" dirty="0">
                        <a:solidFill>
                          <a:schemeClr val="tx1"/>
                        </a:solidFill>
                      </a:rPr>
                      <a:t>Exclusion of certain medications:</a:t>
                    </a:r>
                  </a:p>
                  <a:p>
                    <a:r>
                      <a:rPr lang="en-GB" sz="1400" dirty="0">
                        <a:solidFill>
                          <a:schemeClr val="tx1"/>
                        </a:solidFill>
                      </a:rPr>
                      <a:t>Unknown medication</a:t>
                    </a:r>
                  </a:p>
                  <a:p>
                    <a:r>
                      <a:rPr lang="en-GB" sz="1400" dirty="0">
                        <a:solidFill>
                          <a:schemeClr val="tx1"/>
                        </a:solidFill>
                      </a:rPr>
                      <a:t>	231 individual prescriptions</a:t>
                    </a:r>
                  </a:p>
                  <a:p>
                    <a:r>
                      <a:rPr lang="en-GB" sz="1400" dirty="0">
                        <a:solidFill>
                          <a:schemeClr val="tx1"/>
                        </a:solidFill>
                      </a:rPr>
                      <a:t>Anti-infective medication</a:t>
                    </a:r>
                  </a:p>
                  <a:p>
                    <a:r>
                      <a:rPr lang="en-GB" sz="1400" dirty="0">
                        <a:solidFill>
                          <a:schemeClr val="tx1"/>
                        </a:solidFill>
                      </a:rPr>
                      <a:t>	253 individual prescriptions</a:t>
                    </a:r>
                  </a:p>
                  <a:p>
                    <a:r>
                      <a:rPr lang="en-GB" sz="1400" dirty="0">
                        <a:solidFill>
                          <a:schemeClr val="tx1"/>
                        </a:solidFill>
                      </a:rPr>
                      <a:t>Non-oral medication</a:t>
                    </a:r>
                  </a:p>
                  <a:p>
                    <a:r>
                      <a:rPr lang="en-GB" sz="1400" dirty="0">
                        <a:solidFill>
                          <a:schemeClr val="tx1"/>
                        </a:solidFill>
                      </a:rPr>
                      <a:t>	2,420 individual prescriptions</a:t>
                    </a:r>
                  </a:p>
                </p:txBody>
              </p:sp>
            </p:grpSp>
            <p:cxnSp>
              <p:nvCxnSpPr>
                <p:cNvPr id="7" name="Straight Arrow Connector 6">
                  <a:extLst>
                    <a:ext uri="{FF2B5EF4-FFF2-40B4-BE49-F238E27FC236}">
                      <a16:creationId xmlns:a16="http://schemas.microsoft.com/office/drawing/2014/main" id="{D900AC25-92D9-24DB-9B45-94A0A87CCC8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13229" y="248648"/>
                  <a:ext cx="0" cy="1893065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" name="Straight Arrow Connector 3">
                <a:extLst>
                  <a:ext uri="{FF2B5EF4-FFF2-40B4-BE49-F238E27FC236}">
                    <a16:creationId xmlns:a16="http://schemas.microsoft.com/office/drawing/2014/main" id="{43792396-564E-073C-F409-FDF215681EB3}"/>
                  </a:ext>
                </a:extLst>
              </p:cNvPr>
              <p:cNvCxnSpPr>
                <a:cxnSpLocks/>
                <a:endCxn id="15" idx="1"/>
              </p:cNvCxnSpPr>
              <p:nvPr/>
            </p:nvCxnSpPr>
            <p:spPr>
              <a:xfrm>
                <a:off x="-10691" y="1200418"/>
                <a:ext cx="183186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6BD63F04-AE5D-D6A0-3DE2-7909FE089074}"/>
              </a:ext>
            </a:extLst>
          </p:cNvPr>
          <p:cNvSpPr txBox="1"/>
          <p:nvPr/>
        </p:nvSpPr>
        <p:spPr>
          <a:xfrm>
            <a:off x="125719" y="155099"/>
            <a:ext cx="67322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tailed cohort flow diagram showing the numbers of participants, study visits and prescribed medications at each stage, alongside the exclusion criteria that were applied.</a:t>
            </a:r>
            <a:endParaRPr lang="en-GB" sz="1400" b="1" dirty="0"/>
          </a:p>
        </p:txBody>
      </p:sp>
    </p:spTree>
    <p:extLst>
      <p:ext uri="{BB962C8B-B14F-4D97-AF65-F5344CB8AC3E}">
        <p14:creationId xmlns:p14="http://schemas.microsoft.com/office/powerpoint/2010/main" val="2067598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211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Letts</dc:creator>
  <cp:lastModifiedBy>Matthew Letts</cp:lastModifiedBy>
  <cp:revision>2</cp:revision>
  <dcterms:created xsi:type="dcterms:W3CDTF">2023-10-10T09:36:24Z</dcterms:created>
  <dcterms:modified xsi:type="dcterms:W3CDTF">2024-10-23T09:01:51Z</dcterms:modified>
</cp:coreProperties>
</file>